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6076" autoAdjust="0"/>
  </p:normalViewPr>
  <p:slideViewPr>
    <p:cSldViewPr snapToGrid="0">
      <p:cViewPr>
        <p:scale>
          <a:sx n="112" d="100"/>
          <a:sy n="112" d="100"/>
        </p:scale>
        <p:origin x="1560" y="-27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B9B90A21-F873-3040-5250-233264935F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546" y="1543551"/>
            <a:ext cx="5963629" cy="51427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1EA2ACE-EBD9-4BD0-B5E9-F86B53BCF2E8}"/>
              </a:ext>
            </a:extLst>
          </p:cNvPr>
          <p:cNvSpPr/>
          <p:nvPr/>
        </p:nvSpPr>
        <p:spPr>
          <a:xfrm>
            <a:off x="166953" y="7057098"/>
            <a:ext cx="6408813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2: Figure S2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etic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iversity in antimicrobial activity of primary dormant seed exudates on the 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GB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velopment at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. Lag phase is calculated as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X- intercept of the regression line obtained during the exponential growth phase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determined (NA) for H10-131 seed exudate due to the total inhibition.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. Average slope. C. Maximum slope. D. Time to reach maximum slope. C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trol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responds to growth of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rain Ab43 without exudate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 the box plots correspond to the three technical replicates per biological replicate (n). n=1 for Ab43 (control); n=2 for H10-165 and n=3 for others tested genotypes. A star indicates a significant difference from the control (Mann-Whitney test, p&lt;0.05). RNU, relative nephelometry units.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4864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2</TotalTime>
  <Words>160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08</cp:revision>
  <dcterms:created xsi:type="dcterms:W3CDTF">2023-08-10T14:53:51Z</dcterms:created>
  <dcterms:modified xsi:type="dcterms:W3CDTF">2024-01-17T14:25:41Z</dcterms:modified>
</cp:coreProperties>
</file>